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notesMasterIdLst>
    <p:notesMasterId r:id="rId3"/>
  </p:notesMasterIdLst>
  <p:sldIdLst>
    <p:sldId id="257" r:id="rId2"/>
  </p:sldIdLst>
  <p:sldSz cx="12344400" cy="10515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2" autoAdjust="0"/>
    <p:restoredTop sz="95677" autoAdjust="0"/>
  </p:normalViewPr>
  <p:slideViewPr>
    <p:cSldViewPr snapToGrid="0">
      <p:cViewPr varScale="1">
        <p:scale>
          <a:sx n="75" d="100"/>
          <a:sy n="75" d="100"/>
        </p:scale>
        <p:origin x="180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FC8C0FE-54E0-4419-B21E-46D3C340E032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617663" y="1143000"/>
            <a:ext cx="36226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C0154D-15BF-46B6-9EB0-0053AE12DD3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22871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25830" y="1720956"/>
            <a:ext cx="10492740" cy="3660987"/>
          </a:xfrm>
        </p:spPr>
        <p:txBody>
          <a:bodyPr anchor="b"/>
          <a:lstStyle>
            <a:lvl1pPr algn="ctr">
              <a:defRPr sz="81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43050" y="5523125"/>
            <a:ext cx="9258300" cy="2538835"/>
          </a:xfrm>
        </p:spPr>
        <p:txBody>
          <a:bodyPr/>
          <a:lstStyle>
            <a:lvl1pPr marL="0" indent="0" algn="ctr">
              <a:buNone/>
              <a:defRPr sz="3240"/>
            </a:lvl1pPr>
            <a:lvl2pPr marL="617220" indent="0" algn="ctr">
              <a:buNone/>
              <a:defRPr sz="2700"/>
            </a:lvl2pPr>
            <a:lvl3pPr marL="1234440" indent="0" algn="ctr">
              <a:buNone/>
              <a:defRPr sz="2430"/>
            </a:lvl3pPr>
            <a:lvl4pPr marL="1851660" indent="0" algn="ctr">
              <a:buNone/>
              <a:defRPr sz="2160"/>
            </a:lvl4pPr>
            <a:lvl5pPr marL="2468880" indent="0" algn="ctr">
              <a:buNone/>
              <a:defRPr sz="2160"/>
            </a:lvl5pPr>
            <a:lvl6pPr marL="3086100" indent="0" algn="ctr">
              <a:buNone/>
              <a:defRPr sz="2160"/>
            </a:lvl6pPr>
            <a:lvl7pPr marL="3703320" indent="0" algn="ctr">
              <a:buNone/>
              <a:defRPr sz="2160"/>
            </a:lvl7pPr>
            <a:lvl8pPr marL="4320540" indent="0" algn="ctr">
              <a:buNone/>
              <a:defRPr sz="2160"/>
            </a:lvl8pPr>
            <a:lvl9pPr marL="4937760" indent="0" algn="ctr">
              <a:buNone/>
              <a:defRPr sz="216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85392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62058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3962" y="559858"/>
            <a:ext cx="2661761" cy="891148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48678" y="559858"/>
            <a:ext cx="7830979" cy="8911485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2842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5705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42249" y="2621600"/>
            <a:ext cx="10647045" cy="4374197"/>
          </a:xfrm>
        </p:spPr>
        <p:txBody>
          <a:bodyPr anchor="b"/>
          <a:lstStyle>
            <a:lvl1pPr>
              <a:defRPr sz="81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2249" y="7037179"/>
            <a:ext cx="10647045" cy="2300287"/>
          </a:xfrm>
        </p:spPr>
        <p:txBody>
          <a:bodyPr/>
          <a:lstStyle>
            <a:lvl1pPr marL="0" indent="0">
              <a:buNone/>
              <a:defRPr sz="3240">
                <a:solidFill>
                  <a:schemeClr val="tx1"/>
                </a:solidFill>
              </a:defRPr>
            </a:lvl1pPr>
            <a:lvl2pPr marL="617220" indent="0">
              <a:buNone/>
              <a:defRPr sz="2700">
                <a:solidFill>
                  <a:schemeClr val="tx1">
                    <a:tint val="75000"/>
                  </a:schemeClr>
                </a:solidFill>
              </a:defRPr>
            </a:lvl2pPr>
            <a:lvl3pPr marL="1234440" indent="0">
              <a:buNone/>
              <a:defRPr sz="2430">
                <a:solidFill>
                  <a:schemeClr val="tx1">
                    <a:tint val="75000"/>
                  </a:schemeClr>
                </a:solidFill>
              </a:defRPr>
            </a:lvl3pPr>
            <a:lvl4pPr marL="185166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4pPr>
            <a:lvl5pPr marL="246888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5pPr>
            <a:lvl6pPr marL="308610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6pPr>
            <a:lvl7pPr marL="370332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7pPr>
            <a:lvl8pPr marL="432054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8pPr>
            <a:lvl9pPr marL="4937760" indent="0">
              <a:buNone/>
              <a:defRPr sz="21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70467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48678" y="2799291"/>
            <a:ext cx="5246370" cy="667205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49353" y="2799291"/>
            <a:ext cx="5246370" cy="667205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33157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285" y="559861"/>
            <a:ext cx="10647045" cy="203253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0287" y="2577783"/>
            <a:ext cx="5222259" cy="1263332"/>
          </a:xfrm>
        </p:spPr>
        <p:txBody>
          <a:bodyPr anchor="b"/>
          <a:lstStyle>
            <a:lvl1pPr marL="0" indent="0">
              <a:buNone/>
              <a:defRPr sz="3240" b="1"/>
            </a:lvl1pPr>
            <a:lvl2pPr marL="617220" indent="0">
              <a:buNone/>
              <a:defRPr sz="2700" b="1"/>
            </a:lvl2pPr>
            <a:lvl3pPr marL="1234440" indent="0">
              <a:buNone/>
              <a:defRPr sz="2430" b="1"/>
            </a:lvl3pPr>
            <a:lvl4pPr marL="1851660" indent="0">
              <a:buNone/>
              <a:defRPr sz="2160" b="1"/>
            </a:lvl4pPr>
            <a:lvl5pPr marL="2468880" indent="0">
              <a:buNone/>
              <a:defRPr sz="2160" b="1"/>
            </a:lvl5pPr>
            <a:lvl6pPr marL="3086100" indent="0">
              <a:buNone/>
              <a:defRPr sz="2160" b="1"/>
            </a:lvl6pPr>
            <a:lvl7pPr marL="3703320" indent="0">
              <a:buNone/>
              <a:defRPr sz="2160" b="1"/>
            </a:lvl7pPr>
            <a:lvl8pPr marL="4320540" indent="0">
              <a:buNone/>
              <a:defRPr sz="2160" b="1"/>
            </a:lvl8pPr>
            <a:lvl9pPr marL="4937760" indent="0">
              <a:buNone/>
              <a:defRPr sz="216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50287" y="3841115"/>
            <a:ext cx="5222259" cy="56497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249353" y="2577783"/>
            <a:ext cx="5247978" cy="1263332"/>
          </a:xfrm>
        </p:spPr>
        <p:txBody>
          <a:bodyPr anchor="b"/>
          <a:lstStyle>
            <a:lvl1pPr marL="0" indent="0">
              <a:buNone/>
              <a:defRPr sz="3240" b="1"/>
            </a:lvl1pPr>
            <a:lvl2pPr marL="617220" indent="0">
              <a:buNone/>
              <a:defRPr sz="2700" b="1"/>
            </a:lvl2pPr>
            <a:lvl3pPr marL="1234440" indent="0">
              <a:buNone/>
              <a:defRPr sz="2430" b="1"/>
            </a:lvl3pPr>
            <a:lvl4pPr marL="1851660" indent="0">
              <a:buNone/>
              <a:defRPr sz="2160" b="1"/>
            </a:lvl4pPr>
            <a:lvl5pPr marL="2468880" indent="0">
              <a:buNone/>
              <a:defRPr sz="2160" b="1"/>
            </a:lvl5pPr>
            <a:lvl6pPr marL="3086100" indent="0">
              <a:buNone/>
              <a:defRPr sz="2160" b="1"/>
            </a:lvl6pPr>
            <a:lvl7pPr marL="3703320" indent="0">
              <a:buNone/>
              <a:defRPr sz="2160" b="1"/>
            </a:lvl7pPr>
            <a:lvl8pPr marL="4320540" indent="0">
              <a:buNone/>
              <a:defRPr sz="2160" b="1"/>
            </a:lvl8pPr>
            <a:lvl9pPr marL="4937760" indent="0">
              <a:buNone/>
              <a:defRPr sz="216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249353" y="3841115"/>
            <a:ext cx="5247978" cy="56497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6263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10224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91138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286" y="701040"/>
            <a:ext cx="3981390" cy="2453640"/>
          </a:xfrm>
        </p:spPr>
        <p:txBody>
          <a:bodyPr anchor="b"/>
          <a:lstStyle>
            <a:lvl1pPr>
              <a:defRPr sz="43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247978" y="1514054"/>
            <a:ext cx="6249353" cy="7472892"/>
          </a:xfrm>
        </p:spPr>
        <p:txBody>
          <a:bodyPr/>
          <a:lstStyle>
            <a:lvl1pPr>
              <a:defRPr sz="4320"/>
            </a:lvl1pPr>
            <a:lvl2pPr>
              <a:defRPr sz="3780"/>
            </a:lvl2pPr>
            <a:lvl3pPr>
              <a:defRPr sz="3240"/>
            </a:lvl3pPr>
            <a:lvl4pPr>
              <a:defRPr sz="2700"/>
            </a:lvl4pPr>
            <a:lvl5pPr>
              <a:defRPr sz="2700"/>
            </a:lvl5pPr>
            <a:lvl6pPr>
              <a:defRPr sz="2700"/>
            </a:lvl6pPr>
            <a:lvl7pPr>
              <a:defRPr sz="2700"/>
            </a:lvl7pPr>
            <a:lvl8pPr>
              <a:defRPr sz="2700"/>
            </a:lvl8pPr>
            <a:lvl9pPr>
              <a:defRPr sz="27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0286" y="3154680"/>
            <a:ext cx="3981390" cy="5844435"/>
          </a:xfrm>
        </p:spPr>
        <p:txBody>
          <a:bodyPr/>
          <a:lstStyle>
            <a:lvl1pPr marL="0" indent="0">
              <a:buNone/>
              <a:defRPr sz="2160"/>
            </a:lvl1pPr>
            <a:lvl2pPr marL="617220" indent="0">
              <a:buNone/>
              <a:defRPr sz="1890"/>
            </a:lvl2pPr>
            <a:lvl3pPr marL="1234440" indent="0">
              <a:buNone/>
              <a:defRPr sz="1620"/>
            </a:lvl3pPr>
            <a:lvl4pPr marL="1851660" indent="0">
              <a:buNone/>
              <a:defRPr sz="1350"/>
            </a:lvl4pPr>
            <a:lvl5pPr marL="2468880" indent="0">
              <a:buNone/>
              <a:defRPr sz="1350"/>
            </a:lvl5pPr>
            <a:lvl6pPr marL="3086100" indent="0">
              <a:buNone/>
              <a:defRPr sz="1350"/>
            </a:lvl6pPr>
            <a:lvl7pPr marL="3703320" indent="0">
              <a:buNone/>
              <a:defRPr sz="1350"/>
            </a:lvl7pPr>
            <a:lvl8pPr marL="4320540" indent="0">
              <a:buNone/>
              <a:defRPr sz="1350"/>
            </a:lvl8pPr>
            <a:lvl9pPr marL="4937760" indent="0">
              <a:buNone/>
              <a:defRPr sz="13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2654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0286" y="701040"/>
            <a:ext cx="3981390" cy="2453640"/>
          </a:xfrm>
        </p:spPr>
        <p:txBody>
          <a:bodyPr anchor="b"/>
          <a:lstStyle>
            <a:lvl1pPr>
              <a:defRPr sz="432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247978" y="1514054"/>
            <a:ext cx="6249353" cy="7472892"/>
          </a:xfrm>
        </p:spPr>
        <p:txBody>
          <a:bodyPr anchor="t"/>
          <a:lstStyle>
            <a:lvl1pPr marL="0" indent="0">
              <a:buNone/>
              <a:defRPr sz="4320"/>
            </a:lvl1pPr>
            <a:lvl2pPr marL="617220" indent="0">
              <a:buNone/>
              <a:defRPr sz="3780"/>
            </a:lvl2pPr>
            <a:lvl3pPr marL="1234440" indent="0">
              <a:buNone/>
              <a:defRPr sz="3240"/>
            </a:lvl3pPr>
            <a:lvl4pPr marL="1851660" indent="0">
              <a:buNone/>
              <a:defRPr sz="2700"/>
            </a:lvl4pPr>
            <a:lvl5pPr marL="2468880" indent="0">
              <a:buNone/>
              <a:defRPr sz="2700"/>
            </a:lvl5pPr>
            <a:lvl6pPr marL="3086100" indent="0">
              <a:buNone/>
              <a:defRPr sz="2700"/>
            </a:lvl6pPr>
            <a:lvl7pPr marL="3703320" indent="0">
              <a:buNone/>
              <a:defRPr sz="2700"/>
            </a:lvl7pPr>
            <a:lvl8pPr marL="4320540" indent="0">
              <a:buNone/>
              <a:defRPr sz="2700"/>
            </a:lvl8pPr>
            <a:lvl9pPr marL="4937760" indent="0">
              <a:buNone/>
              <a:defRPr sz="27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50286" y="3154680"/>
            <a:ext cx="3981390" cy="5844435"/>
          </a:xfrm>
        </p:spPr>
        <p:txBody>
          <a:bodyPr/>
          <a:lstStyle>
            <a:lvl1pPr marL="0" indent="0">
              <a:buNone/>
              <a:defRPr sz="2160"/>
            </a:lvl1pPr>
            <a:lvl2pPr marL="617220" indent="0">
              <a:buNone/>
              <a:defRPr sz="1890"/>
            </a:lvl2pPr>
            <a:lvl3pPr marL="1234440" indent="0">
              <a:buNone/>
              <a:defRPr sz="1620"/>
            </a:lvl3pPr>
            <a:lvl4pPr marL="1851660" indent="0">
              <a:buNone/>
              <a:defRPr sz="1350"/>
            </a:lvl4pPr>
            <a:lvl5pPr marL="2468880" indent="0">
              <a:buNone/>
              <a:defRPr sz="1350"/>
            </a:lvl5pPr>
            <a:lvl6pPr marL="3086100" indent="0">
              <a:buNone/>
              <a:defRPr sz="1350"/>
            </a:lvl6pPr>
            <a:lvl7pPr marL="3703320" indent="0">
              <a:buNone/>
              <a:defRPr sz="1350"/>
            </a:lvl7pPr>
            <a:lvl8pPr marL="4320540" indent="0">
              <a:buNone/>
              <a:defRPr sz="1350"/>
            </a:lvl8pPr>
            <a:lvl9pPr marL="4937760" indent="0">
              <a:buNone/>
              <a:defRPr sz="13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488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48678" y="559861"/>
            <a:ext cx="10647045" cy="203253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48678" y="2799291"/>
            <a:ext cx="10647045" cy="66720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48678" y="9746406"/>
            <a:ext cx="2777490" cy="5598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9982A1-06C9-4E11-A9E3-0EB8523E0810}" type="datetimeFigureOut">
              <a:rPr lang="zh-CN" altLang="en-US" smtClean="0"/>
              <a:t>2020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89083" y="9746406"/>
            <a:ext cx="4166235" cy="5598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18233" y="9746406"/>
            <a:ext cx="2777490" cy="55985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91B09-12AD-4449-9F44-E466264FA3A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044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234440" rtl="0" eaLnBrk="1" latinLnBrk="0" hangingPunct="1">
        <a:lnSpc>
          <a:spcPct val="90000"/>
        </a:lnSpc>
        <a:spcBef>
          <a:spcPct val="0"/>
        </a:spcBef>
        <a:buNone/>
        <a:defRPr sz="59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8610" indent="-308610" algn="l" defTabSz="1234440" rtl="0" eaLnBrk="1" latinLnBrk="0" hangingPunct="1">
        <a:lnSpc>
          <a:spcPct val="90000"/>
        </a:lnSpc>
        <a:spcBef>
          <a:spcPts val="1350"/>
        </a:spcBef>
        <a:buFont typeface="Arial" panose="020B0604020202020204" pitchFamily="34" charset="0"/>
        <a:buChar char="•"/>
        <a:defRPr sz="3780" kern="1200">
          <a:solidFill>
            <a:schemeClr val="tx1"/>
          </a:solidFill>
          <a:latin typeface="+mn-lt"/>
          <a:ea typeface="+mn-ea"/>
          <a:cs typeface="+mn-cs"/>
        </a:defRPr>
      </a:lvl1pPr>
      <a:lvl2pPr marL="92583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2pPr>
      <a:lvl3pPr marL="154305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216027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4pPr>
      <a:lvl5pPr marL="277749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5pPr>
      <a:lvl6pPr marL="339471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6pPr>
      <a:lvl7pPr marL="401193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7pPr>
      <a:lvl8pPr marL="462915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8pPr>
      <a:lvl9pPr marL="5246370" indent="-308610" algn="l" defTabSz="1234440" rtl="0" eaLnBrk="1" latinLnBrk="0" hangingPunct="1">
        <a:lnSpc>
          <a:spcPct val="90000"/>
        </a:lnSpc>
        <a:spcBef>
          <a:spcPts val="675"/>
        </a:spcBef>
        <a:buFont typeface="Arial" panose="020B0604020202020204" pitchFamily="34" charset="0"/>
        <a:buChar char="•"/>
        <a:defRPr sz="24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1pPr>
      <a:lvl2pPr marL="61722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2pPr>
      <a:lvl3pPr marL="123444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3pPr>
      <a:lvl4pPr marL="185166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4pPr>
      <a:lvl5pPr marL="246888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5pPr>
      <a:lvl6pPr marL="308610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6pPr>
      <a:lvl7pPr marL="370332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7pPr>
      <a:lvl8pPr marL="432054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8pPr>
      <a:lvl9pPr marL="4937760" algn="l" defTabSz="1234440" rtl="0" eaLnBrk="1" latinLnBrk="0" hangingPunct="1">
        <a:defRPr sz="24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6B08069-B517-447C-9C2A-D423768C53EA}"/>
              </a:ext>
            </a:extLst>
          </p:cNvPr>
          <p:cNvSpPr txBox="1"/>
          <p:nvPr/>
        </p:nvSpPr>
        <p:spPr>
          <a:xfrm>
            <a:off x="182294" y="89583"/>
            <a:ext cx="2383601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99" dirty="0"/>
              <a:t>Supplementary figure 1</a:t>
            </a:r>
            <a:endParaRPr lang="zh-CN" altLang="en-US" sz="1799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26BA28B1-FF40-4F15-9D5E-EEC417ACBFC3}"/>
              </a:ext>
            </a:extLst>
          </p:cNvPr>
          <p:cNvSpPr txBox="1"/>
          <p:nvPr/>
        </p:nvSpPr>
        <p:spPr>
          <a:xfrm>
            <a:off x="182294" y="458787"/>
            <a:ext cx="317716" cy="36920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799" dirty="0"/>
              <a:t>A</a:t>
            </a:r>
            <a:endParaRPr lang="zh-CN" altLang="en-US" sz="1799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DE871936-618E-4FB4-909B-CE89EC6072B4}"/>
              </a:ext>
            </a:extLst>
          </p:cNvPr>
          <p:cNvSpPr txBox="1"/>
          <p:nvPr/>
        </p:nvSpPr>
        <p:spPr>
          <a:xfrm>
            <a:off x="5760683" y="458788"/>
            <a:ext cx="448733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99" dirty="0"/>
              <a:t>B</a:t>
            </a:r>
            <a:endParaRPr lang="zh-CN" altLang="en-US" sz="1799" dirty="0"/>
          </a:p>
        </p:txBody>
      </p:sp>
      <p:pic>
        <p:nvPicPr>
          <p:cNvPr id="8" name="Picture 4">
            <a:extLst>
              <a:ext uri="{FF2B5EF4-FFF2-40B4-BE49-F238E27FC236}">
                <a16:creationId xmlns:a16="http://schemas.microsoft.com/office/drawing/2014/main" id="{5C23D133-CFC9-425F-A2A7-108E744CEF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425" y="827992"/>
            <a:ext cx="5396127" cy="3749041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8E66BB47-CE69-404E-8D0E-95027498DB8D}"/>
              </a:ext>
            </a:extLst>
          </p:cNvPr>
          <p:cNvSpPr txBox="1"/>
          <p:nvPr/>
        </p:nvSpPr>
        <p:spPr>
          <a:xfrm>
            <a:off x="141449" y="8909021"/>
            <a:ext cx="11924427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200" dirty="0"/>
              <a:t>Supplementary figure 1. A. </a:t>
            </a:r>
            <a:r>
              <a:rPr lang="en-US" altLang="zh-CN" sz="2200" dirty="0" err="1"/>
              <a:t>cfDNA</a:t>
            </a:r>
            <a:r>
              <a:rPr lang="en-US" altLang="zh-CN" sz="2200" dirty="0"/>
              <a:t> methylation markers for AP prediction achieved an AUC of 0.91 on classifying healthy and AP samples in the training set; B. The 20-marker SAP prediction model performed robustly in classifying training MAP and SAP samples; C. but it underperformed on the test set, demanding adjustment in selecting biomarkers and rebuilding prediction </a:t>
            </a:r>
            <a:r>
              <a:rPr lang="en-US" altLang="zh-CN" sz="2200"/>
              <a:t>model. </a:t>
            </a:r>
            <a:endParaRPr lang="zh-CN" altLang="en-US" sz="2200" dirty="0"/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B190A56D-4913-4816-8760-BF4D8CD3A27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152" y="5001548"/>
            <a:ext cx="5401526" cy="3749040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661D1F0B-39FA-43F6-8B08-063A1DD9D778}"/>
              </a:ext>
            </a:extLst>
          </p:cNvPr>
          <p:cNvSpPr txBox="1"/>
          <p:nvPr/>
        </p:nvSpPr>
        <p:spPr>
          <a:xfrm>
            <a:off x="182294" y="4632344"/>
            <a:ext cx="448733" cy="3692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799" dirty="0"/>
              <a:t>C</a:t>
            </a:r>
            <a:endParaRPr lang="zh-CN" altLang="en-US" sz="1799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9A0F12F2-3E2A-43DE-B401-48C66DD40688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1773" y="883304"/>
            <a:ext cx="5401526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6753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2</TotalTime>
  <Words>71</Words>
  <Application>Microsoft Office PowerPoint</Application>
  <PresentationFormat>自定义</PresentationFormat>
  <Paragraphs>5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hael He 何其晔, SGI</dc:creator>
  <cp:lastModifiedBy>Shi Keqing</cp:lastModifiedBy>
  <cp:revision>20</cp:revision>
  <cp:lastPrinted>2018-09-13T06:49:48Z</cp:lastPrinted>
  <dcterms:created xsi:type="dcterms:W3CDTF">2018-09-11T11:25:29Z</dcterms:created>
  <dcterms:modified xsi:type="dcterms:W3CDTF">2020-01-06T03:07:46Z</dcterms:modified>
</cp:coreProperties>
</file>